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4" r:id="rId4"/>
    <p:sldId id="259" r:id="rId5"/>
    <p:sldId id="265" r:id="rId6"/>
    <p:sldId id="266" r:id="rId7"/>
    <p:sldId id="269" r:id="rId8"/>
    <p:sldId id="267" r:id="rId9"/>
    <p:sldId id="260" r:id="rId10"/>
    <p:sldId id="261" r:id="rId11"/>
    <p:sldId id="270" r:id="rId12"/>
    <p:sldId id="271" r:id="rId13"/>
    <p:sldId id="262" r:id="rId14"/>
    <p:sldId id="263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3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80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031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799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35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540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53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413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124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824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474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1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9A7F8D-B9A3-433A-9B06-AFEEC19C6E8A}" type="datetimeFigureOut">
              <a:rPr lang="en-US" smtClean="0"/>
              <a:t>7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1AEBB-8CDF-4DF3-97F6-5889483AC4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589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Relationship Id="rId9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3726" y="692705"/>
            <a:ext cx="11127036" cy="2799642"/>
          </a:xfrm>
        </p:spPr>
        <p:txBody>
          <a:bodyPr>
            <a:normAutofit fontScale="90000"/>
          </a:bodyPr>
          <a:lstStyle/>
          <a:p>
            <a:r>
              <a:rPr lang="en-GB" b="1" dirty="0"/>
              <a:t>Unbiased screening identifies functional differences in NK cells after early life psycho-sociological stress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594910" y="5408361"/>
            <a:ext cx="1041094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</a:pP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ra B. Fernandes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eha D. Patil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ophie Meriaux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ud Theresine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laude. P. Muller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leur A.D. Leenen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tha M.C. Elwenspoek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4 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acques Zimmer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fr-CH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onathan Turner</a:t>
            </a:r>
            <a:r>
              <a:rPr lang="fr-CH" sz="1600" baseline="30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*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84831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4: </a:t>
            </a:r>
            <a:r>
              <a:rPr lang="en-US" sz="1800" dirty="0" smtClean="0"/>
              <a:t>Flow cytometry gating strategy for the quantification of NK cell maturation </a:t>
            </a:r>
            <a:r>
              <a:rPr lang="en-US" sz="1800" dirty="0" smtClean="0"/>
              <a:t>state (Figure 4). </a:t>
            </a:r>
            <a:endParaRPr lang="en-US" sz="18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202" y="1427545"/>
            <a:ext cx="3757039" cy="361916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08157" y="1477121"/>
            <a:ext cx="3654109" cy="352001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94182" y="1477121"/>
            <a:ext cx="3705732" cy="35697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82356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8228" b="6796"/>
          <a:stretch/>
        </p:blipFill>
        <p:spPr>
          <a:xfrm>
            <a:off x="638978" y="1576272"/>
            <a:ext cx="3194892" cy="319403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8544" b="5831"/>
          <a:stretch/>
        </p:blipFill>
        <p:spPr>
          <a:xfrm>
            <a:off x="4572000" y="1576272"/>
            <a:ext cx="3183874" cy="32270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9035" b="6982"/>
          <a:stretch/>
        </p:blipFill>
        <p:spPr>
          <a:xfrm>
            <a:off x="8339768" y="1576272"/>
            <a:ext cx="3216925" cy="323809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69646" y="2689574"/>
            <a:ext cx="400110" cy="12003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Live/Dead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9584675" y="4864706"/>
            <a:ext cx="11016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NKp46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059981" y="2689574"/>
            <a:ext cx="615553" cy="12003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NKR-P1 (CD161a)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7860264" y="2689574"/>
            <a:ext cx="615553" cy="120032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NKR-P1 (CD161a)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5607585" y="4864705"/>
            <a:ext cx="11016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3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685580" y="4864704"/>
            <a:ext cx="11016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3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4: </a:t>
            </a:r>
            <a:r>
              <a:rPr lang="en-US" sz="1800" dirty="0" smtClean="0"/>
              <a:t>Flow cytometry gating strategy for the quantification of NK cell maturation state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41386966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8517" b="4894"/>
          <a:stretch/>
        </p:blipFill>
        <p:spPr>
          <a:xfrm>
            <a:off x="694063" y="1710111"/>
            <a:ext cx="3194890" cy="32695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7500" b="6103"/>
          <a:stretch/>
        </p:blipFill>
        <p:spPr>
          <a:xfrm>
            <a:off x="4461830" y="1710110"/>
            <a:ext cx="3260993" cy="325849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9063" b="5953"/>
          <a:stretch/>
        </p:blipFill>
        <p:spPr>
          <a:xfrm>
            <a:off x="8350785" y="1693842"/>
            <a:ext cx="3205909" cy="326374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7536" y="2632719"/>
            <a:ext cx="430887" cy="70788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en-US"/>
            </a:defPPr>
            <a:lvl1pPr algn="ctr">
              <a:defRPr sz="2000" b="1">
                <a:solidFill>
                  <a:srgbClr val="FF0000"/>
                </a:solidFill>
              </a:defRPr>
            </a:lvl1pPr>
          </a:lstStyle>
          <a:p>
            <a:r>
              <a:rPr lang="en-US" sz="1600" dirty="0">
                <a:solidFill>
                  <a:schemeClr val="tx1"/>
                </a:solidFill>
              </a:rPr>
              <a:t>CD2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66132" y="5245198"/>
            <a:ext cx="10434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CD11b</a:t>
            </a:r>
            <a:endParaRPr lang="en-US" sz="1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02013" y="5645308"/>
            <a:ext cx="23334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Q1: </a:t>
            </a:r>
            <a:r>
              <a:rPr lang="en-US" sz="1400" dirty="0" smtClean="0"/>
              <a:t>CD27+, CD11b-</a:t>
            </a:r>
          </a:p>
          <a:p>
            <a:r>
              <a:rPr lang="en-US" sz="1400" b="1" dirty="0" smtClean="0"/>
              <a:t>Q2: </a:t>
            </a:r>
            <a:r>
              <a:rPr lang="en-US" sz="1400" dirty="0" smtClean="0"/>
              <a:t>CD27+, CD11b +</a:t>
            </a:r>
          </a:p>
          <a:p>
            <a:r>
              <a:rPr lang="en-US" sz="1400" b="1" dirty="0" smtClean="0"/>
              <a:t>Q3: </a:t>
            </a:r>
            <a:r>
              <a:rPr lang="en-US" sz="1400" dirty="0" smtClean="0"/>
              <a:t>CD27-, CD11b +</a:t>
            </a:r>
          </a:p>
          <a:p>
            <a:r>
              <a:rPr lang="en-US" sz="1400" b="1" dirty="0" smtClean="0"/>
              <a:t>Q4: </a:t>
            </a:r>
            <a:r>
              <a:rPr lang="en-US" sz="1400" dirty="0" smtClean="0"/>
              <a:t>CD27-, CD11b -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554900" y="1322429"/>
            <a:ext cx="1355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MD</a:t>
            </a:r>
            <a:r>
              <a:rPr lang="en-US" b="1" baseline="-25000" dirty="0"/>
              <a:t>15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322839" y="1319149"/>
            <a:ext cx="1355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Control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281390" y="1322429"/>
            <a:ext cx="1355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MD</a:t>
            </a:r>
            <a:r>
              <a:rPr lang="en-US" b="1" baseline="-25000" dirty="0"/>
              <a:t>180</a:t>
            </a:r>
            <a:endParaRPr lang="en-US" b="1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040524" y="5099968"/>
            <a:ext cx="10516170" cy="2488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 flipV="1">
            <a:off x="631639" y="1189822"/>
            <a:ext cx="7465" cy="385913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4: </a:t>
            </a:r>
            <a:r>
              <a:rPr lang="en-US" sz="1800" dirty="0" smtClean="0"/>
              <a:t>Flow cytometry gating strategy for the quantification of NK cell maturation state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45626226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5667" y="1013212"/>
            <a:ext cx="3917169" cy="289004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8834" y="1111732"/>
            <a:ext cx="3783634" cy="27915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21064" y="4036622"/>
            <a:ext cx="3586376" cy="264599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06969" y="4011055"/>
            <a:ext cx="3695499" cy="2671557"/>
          </a:xfrm>
          <a:prstGeom prst="rect">
            <a:avLst/>
          </a:prstGeom>
        </p:spPr>
      </p:pic>
      <p:sp>
        <p:nvSpPr>
          <p:cNvPr id="9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5: </a:t>
            </a:r>
            <a:r>
              <a:rPr lang="en-US" sz="1800" dirty="0" smtClean="0"/>
              <a:t>Correlation analysis between CMV titers and cytotoxic response of NK cells of institutionalized individuals. 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806078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4701" y="2502867"/>
            <a:ext cx="2673015" cy="204407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1919" y="2470469"/>
            <a:ext cx="2695417" cy="207646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1412" y="4582314"/>
            <a:ext cx="2636432" cy="20375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57844" y="4524865"/>
            <a:ext cx="2765373" cy="213036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98212" y="2486667"/>
            <a:ext cx="2653360" cy="204407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2918" y="4585039"/>
            <a:ext cx="2687266" cy="207018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04701" y="178391"/>
            <a:ext cx="2843803" cy="225397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9446" y="3547431"/>
            <a:ext cx="2794158" cy="2871132"/>
          </a:xfrm>
          <a:prstGeom prst="rect">
            <a:avLst/>
          </a:prstGeom>
        </p:spPr>
      </p:pic>
      <p:sp>
        <p:nvSpPr>
          <p:cNvPr id="11" name="Title 1"/>
          <p:cNvSpPr txBox="1">
            <a:spLocks/>
          </p:cNvSpPr>
          <p:nvPr/>
        </p:nvSpPr>
        <p:spPr>
          <a:xfrm>
            <a:off x="116083" y="99151"/>
            <a:ext cx="4026979" cy="344828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6: (</a:t>
            </a:r>
            <a:r>
              <a:rPr lang="en-US" sz="1800" dirty="0" smtClean="0"/>
              <a:t>A): representative image of the NK cell population gating strategy: 1– CD56brightCD16-; 2 –CD56brightCD16+; 3- CD56dimCD16+; 4– CD56dimCD16dim; 5- CD56dimCD16bright; 6 – CD56-CD16bright. Rest of the figures show the release of IFN-γ and CD107a by the different NK cell populations. No significant differences were found. Data is presented as mean ± SEM of 14 donor per group</a:t>
            </a:r>
            <a:r>
              <a:rPr lang="en-US" sz="1800" b="1" dirty="0" smtClean="0"/>
              <a:t>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737428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359884" y="112736"/>
            <a:ext cx="11604434" cy="780503"/>
          </a:xfr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800" b="1" dirty="0"/>
              <a:t>Supplementary figure 1: </a:t>
            </a:r>
            <a:r>
              <a:rPr lang="en-US" sz="1800" dirty="0" err="1"/>
              <a:t>viSNE</a:t>
            </a:r>
            <a:r>
              <a:rPr lang="en-US" sz="1800" dirty="0"/>
              <a:t> clusters definition based on the used markers. Clusters colored by CD3, CD4 and CD8 cell markers to identify immune populations associated.</a:t>
            </a:r>
            <a:r>
              <a:rPr lang="en-US" sz="1800" b="1" dirty="0"/>
              <a:t> </a:t>
            </a:r>
            <a:r>
              <a:rPr lang="en-US" sz="1800" dirty="0"/>
              <a:t>Blue to orange: low to high expression of the marker.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608" y="1371291"/>
            <a:ext cx="10916769" cy="4566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7296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293783" y="133774"/>
            <a:ext cx="11604434" cy="780503"/>
          </a:xfr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800" b="1" dirty="0"/>
              <a:t>Supplementary figure 1: </a:t>
            </a:r>
            <a:r>
              <a:rPr lang="en-US" sz="1800" dirty="0" err="1"/>
              <a:t>viSNE</a:t>
            </a:r>
            <a:r>
              <a:rPr lang="en-US" sz="1800" dirty="0"/>
              <a:t> clusters definition based on the used markers. Clusters colored by CD3, CD4 and CD8 cell markers to identify immune populations associated.</a:t>
            </a:r>
            <a:r>
              <a:rPr lang="en-US" sz="1800" b="1" dirty="0"/>
              <a:t> </a:t>
            </a:r>
            <a:r>
              <a:rPr lang="en-US" sz="1800" dirty="0"/>
              <a:t>Blue to orange: low to high expression of the marker.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306" y="1044419"/>
            <a:ext cx="9315626" cy="538943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19340" y="1509553"/>
            <a:ext cx="16525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3</a:t>
            </a:r>
            <a:endParaRPr lang="en-US" sz="11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19340" y="2853993"/>
            <a:ext cx="16525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4</a:t>
            </a:r>
            <a:endParaRPr lang="en-US" sz="11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919340" y="4336168"/>
            <a:ext cx="16525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8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710402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876" y="1541374"/>
            <a:ext cx="10288248" cy="467214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090669" y="1208844"/>
            <a:ext cx="2412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45RA</a:t>
            </a:r>
            <a:endParaRPr lang="en-US" sz="1100" b="1" dirty="0"/>
          </a:p>
        </p:txBody>
      </p:sp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229518" y="135391"/>
            <a:ext cx="11732964" cy="744456"/>
          </a:xfrm>
        </p:spPr>
        <p:txBody>
          <a:bodyPr vert="horz" lIns="91440" tIns="45720" rIns="91440" bIns="45720" rtlCol="0" anchor="ctr">
            <a:noAutofit/>
          </a:bodyPr>
          <a:lstStyle/>
          <a:p>
            <a:pPr algn="just"/>
            <a:r>
              <a:rPr lang="en-US" sz="1800" b="1" dirty="0"/>
              <a:t>Supplementary figure 2: </a:t>
            </a:r>
            <a:r>
              <a:rPr lang="en-US" sz="1800" dirty="0" smtClean="0"/>
              <a:t>Clusters </a:t>
            </a:r>
            <a:r>
              <a:rPr lang="en-US" sz="1800" dirty="0"/>
              <a:t>colored by CD45RA, CD11b/c, CD25 and FoxP3 cell markers to identify immune populations associated. Blue to orange: low to high expression of the marker.</a:t>
            </a:r>
          </a:p>
        </p:txBody>
      </p:sp>
    </p:spTree>
    <p:extLst>
      <p:ext uri="{BB962C8B-B14F-4D97-AF65-F5344CB8AC3E}">
        <p14:creationId xmlns:p14="http://schemas.microsoft.com/office/powerpoint/2010/main" val="3454795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9648" y="1576926"/>
            <a:ext cx="10512704" cy="4603537"/>
          </a:xfrm>
          <a:prstGeom prst="rect">
            <a:avLst/>
          </a:prstGeom>
        </p:spPr>
      </p:pic>
      <p:sp>
        <p:nvSpPr>
          <p:cNvPr id="12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smtClean="0"/>
              <a:t>Supplementary figure 2: </a:t>
            </a:r>
            <a:r>
              <a:rPr lang="en-US" sz="1800" smtClean="0"/>
              <a:t>Clusters colored by CD45RA, CD11b/c, CD25 and FoxP3 cell markers to identify immune populations associated. Blue to orange: low to high expression of the marker.</a:t>
            </a:r>
            <a:endParaRPr lang="en-US" sz="1800" dirty="0"/>
          </a:p>
        </p:txBody>
      </p:sp>
      <p:sp>
        <p:nvSpPr>
          <p:cNvPr id="16" name="TextBox 15"/>
          <p:cNvSpPr txBox="1"/>
          <p:nvPr/>
        </p:nvSpPr>
        <p:spPr>
          <a:xfrm>
            <a:off x="1090669" y="1208844"/>
            <a:ext cx="2412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11b/c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06473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6316" y="1470454"/>
            <a:ext cx="8728053" cy="5197701"/>
          </a:xfrm>
        </p:spPr>
      </p:pic>
      <p:sp>
        <p:nvSpPr>
          <p:cNvPr id="11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2: </a:t>
            </a:r>
            <a:r>
              <a:rPr lang="en-US" sz="1800" dirty="0" smtClean="0"/>
              <a:t>Clusters colored by CD45RA, CD11b/c, CD25 and FoxP3 cell markers to identify immune populations associated. Blue to orange: low to high expression of the marker.</a:t>
            </a:r>
            <a:endParaRPr lang="en-US" sz="1800" dirty="0"/>
          </a:p>
        </p:txBody>
      </p:sp>
      <p:sp>
        <p:nvSpPr>
          <p:cNvPr id="12" name="TextBox 11"/>
          <p:cNvSpPr txBox="1"/>
          <p:nvPr/>
        </p:nvSpPr>
        <p:spPr>
          <a:xfrm>
            <a:off x="-77119" y="2024092"/>
            <a:ext cx="2412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CD25</a:t>
            </a:r>
            <a:endParaRPr lang="en-US" sz="11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-77119" y="4490034"/>
            <a:ext cx="24126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/>
              <a:t>Colored by FoxP3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4195266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b="33672"/>
          <a:stretch/>
        </p:blipFill>
        <p:spPr>
          <a:xfrm>
            <a:off x="641560" y="2104222"/>
            <a:ext cx="3290320" cy="34137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b="34535"/>
          <a:stretch/>
        </p:blipFill>
        <p:spPr>
          <a:xfrm>
            <a:off x="4651703" y="2104222"/>
            <a:ext cx="3281700" cy="336047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b="34535"/>
          <a:stretch/>
        </p:blipFill>
        <p:spPr>
          <a:xfrm>
            <a:off x="8518621" y="2104222"/>
            <a:ext cx="3281699" cy="3360469"/>
          </a:xfrm>
          <a:prstGeom prst="rect">
            <a:avLst/>
          </a:prstGeom>
        </p:spPr>
      </p:pic>
      <p:sp>
        <p:nvSpPr>
          <p:cNvPr id="7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3: </a:t>
            </a:r>
            <a:r>
              <a:rPr lang="en-US" sz="1800" dirty="0" smtClean="0"/>
              <a:t>Flow cytometry </a:t>
            </a:r>
            <a:r>
              <a:rPr lang="en-US" sz="1800" dirty="0"/>
              <a:t>g</a:t>
            </a:r>
            <a:r>
              <a:rPr lang="en-US" sz="1800" dirty="0" smtClean="0"/>
              <a:t>ating strategy for quantification </a:t>
            </a:r>
            <a:r>
              <a:rPr lang="en-US" sz="1800" dirty="0"/>
              <a:t>of long-term changes in the immune </a:t>
            </a:r>
            <a:r>
              <a:rPr lang="en-US" sz="1800" dirty="0" smtClean="0"/>
              <a:t>system after maternal </a:t>
            </a:r>
            <a:r>
              <a:rPr lang="en-US" sz="1800" dirty="0" smtClean="0"/>
              <a:t>deprivation (Figure 3 all panels).</a:t>
            </a:r>
            <a:endParaRPr lang="en-US" sz="1800" dirty="0"/>
          </a:p>
        </p:txBody>
      </p:sp>
      <p:sp>
        <p:nvSpPr>
          <p:cNvPr id="8" name="TextBox 7"/>
          <p:cNvSpPr txBox="1"/>
          <p:nvPr/>
        </p:nvSpPr>
        <p:spPr>
          <a:xfrm>
            <a:off x="207484" y="3051672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229559" y="3045792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092464" y="3045792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718631" y="551794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SSC-H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401937" y="551794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FSC-A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9465407" y="551794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45RA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4353572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b="34535"/>
          <a:stretch/>
        </p:blipFill>
        <p:spPr>
          <a:xfrm>
            <a:off x="817830" y="1822948"/>
            <a:ext cx="3168753" cy="324481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b="34535"/>
          <a:stretch/>
        </p:blipFill>
        <p:spPr>
          <a:xfrm>
            <a:off x="4673734" y="1822948"/>
            <a:ext cx="3168753" cy="324481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/>
          <a:srcRect l="-1350" t="-576" r="1350" b="35111"/>
          <a:stretch/>
        </p:blipFill>
        <p:spPr>
          <a:xfrm>
            <a:off x="8529638" y="1822948"/>
            <a:ext cx="3168753" cy="3244811"/>
          </a:xfrm>
          <a:prstGeom prst="rect">
            <a:avLst/>
          </a:prstGeom>
        </p:spPr>
      </p:pic>
      <p:sp>
        <p:nvSpPr>
          <p:cNvPr id="10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3: </a:t>
            </a:r>
            <a:r>
              <a:rPr lang="en-US" sz="1800" dirty="0" smtClean="0"/>
              <a:t>Flow cytometry </a:t>
            </a:r>
            <a:r>
              <a:rPr lang="en-US" sz="1800" dirty="0"/>
              <a:t>g</a:t>
            </a:r>
            <a:r>
              <a:rPr lang="en-US" sz="1800" dirty="0" smtClean="0"/>
              <a:t>ating strategy for quantification </a:t>
            </a:r>
            <a:r>
              <a:rPr lang="en-US" sz="1800" dirty="0"/>
              <a:t>of long-term changes in the immune </a:t>
            </a:r>
            <a:r>
              <a:rPr lang="en-US" sz="1800" dirty="0" smtClean="0"/>
              <a:t>system after maternal </a:t>
            </a:r>
            <a:r>
              <a:rPr lang="en-US" sz="1800" dirty="0" smtClean="0"/>
              <a:t>deprivation (Figure 3A).</a:t>
            </a:r>
            <a:endParaRPr lang="en-US" sz="1800" dirty="0"/>
          </a:p>
        </p:txBody>
      </p:sp>
      <p:sp>
        <p:nvSpPr>
          <p:cNvPr id="11" name="TextBox 10"/>
          <p:cNvSpPr txBox="1"/>
          <p:nvPr/>
        </p:nvSpPr>
        <p:spPr>
          <a:xfrm>
            <a:off x="1553378" y="517311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3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236684" y="517311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4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9300154" y="5173112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8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74200" y="2706689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273624" y="2706689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053241" y="2706689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9357674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b="33960"/>
          <a:stretch/>
        </p:blipFill>
        <p:spPr>
          <a:xfrm>
            <a:off x="674310" y="2009884"/>
            <a:ext cx="3185711" cy="329085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b="35110"/>
          <a:stretch/>
        </p:blipFill>
        <p:spPr>
          <a:xfrm>
            <a:off x="4510521" y="2034650"/>
            <a:ext cx="3217812" cy="32660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b="35686"/>
          <a:stretch/>
        </p:blipFill>
        <p:spPr>
          <a:xfrm>
            <a:off x="8504136" y="2034650"/>
            <a:ext cx="3188346" cy="3266086"/>
          </a:xfrm>
          <a:prstGeom prst="rect">
            <a:avLst/>
          </a:prstGeom>
        </p:spPr>
      </p:pic>
      <p:sp>
        <p:nvSpPr>
          <p:cNvPr id="13" name="Title 1"/>
          <p:cNvSpPr txBox="1">
            <a:spLocks/>
          </p:cNvSpPr>
          <p:nvPr/>
        </p:nvSpPr>
        <p:spPr>
          <a:xfrm>
            <a:off x="229518" y="135391"/>
            <a:ext cx="11732964" cy="7444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800" b="1" dirty="0" smtClean="0"/>
              <a:t>Supplementary figure 3: </a:t>
            </a:r>
            <a:r>
              <a:rPr lang="en-US" sz="1800" dirty="0" smtClean="0"/>
              <a:t>Flow cytometry </a:t>
            </a:r>
            <a:r>
              <a:rPr lang="en-US" sz="1800" dirty="0"/>
              <a:t>g</a:t>
            </a:r>
            <a:r>
              <a:rPr lang="en-US" sz="1800" dirty="0" smtClean="0"/>
              <a:t>ating strategy for quantification </a:t>
            </a:r>
            <a:r>
              <a:rPr lang="en-US" sz="1800" dirty="0"/>
              <a:t>of long-term changes in the immune </a:t>
            </a:r>
            <a:r>
              <a:rPr lang="en-US" sz="1800" dirty="0" smtClean="0"/>
              <a:t>system after maternal </a:t>
            </a:r>
            <a:r>
              <a:rPr lang="en-US" sz="1800" dirty="0" smtClean="0"/>
              <a:t>deprivation </a:t>
            </a:r>
            <a:r>
              <a:rPr lang="en-US" sz="1800" smtClean="0"/>
              <a:t>(Figure 2B/C).</a:t>
            </a:r>
            <a:endParaRPr lang="en-US" sz="1800" dirty="0"/>
          </a:p>
        </p:txBody>
      </p:sp>
      <p:sp>
        <p:nvSpPr>
          <p:cNvPr id="14" name="TextBox 13"/>
          <p:cNvSpPr txBox="1"/>
          <p:nvPr/>
        </p:nvSpPr>
        <p:spPr>
          <a:xfrm>
            <a:off x="229518" y="2916646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FSC-H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573102" y="5300736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161a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425364" y="5300736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161a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048089" y="2916646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CD3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8031668" y="2916646"/>
            <a:ext cx="400110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400" b="1" dirty="0" smtClean="0"/>
              <a:t>CD4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404246" y="5300736"/>
            <a:ext cx="138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D8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29700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38</Words>
  <Application>Microsoft Office PowerPoint</Application>
  <PresentationFormat>Widescreen</PresentationFormat>
  <Paragraphs>55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Unbiased screening identifies functional differences in NK cells after early life psycho-sociological stress</vt:lpstr>
      <vt:lpstr>Supplementary figure 1: viSNE clusters definition based on the used markers. Clusters colored by CD3, CD4 and CD8 cell markers to identify immune populations associated. Blue to orange: low to high expression of the marker.</vt:lpstr>
      <vt:lpstr>Supplementary figure 1: viSNE clusters definition based on the used markers. Clusters colored by CD3, CD4 and CD8 cell markers to identify immune populations associated. Blue to orange: low to high expression of the marker.</vt:lpstr>
      <vt:lpstr>Supplementary figure 2: Clusters colored by CD45RA, CD11b/c, CD25 and FoxP3 cell markers to identify immune populations associated. Blue to orange: low to high expression of the marker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uxembourg Institute of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biased screening identifies functional differences in NK cells after early life psycho-sociological stress</dc:title>
  <dc:creator>Sara Beatriz Fernandes</dc:creator>
  <cp:lastModifiedBy>Jonathan Turner</cp:lastModifiedBy>
  <cp:revision>9</cp:revision>
  <dcterms:created xsi:type="dcterms:W3CDTF">2021-02-25T10:43:50Z</dcterms:created>
  <dcterms:modified xsi:type="dcterms:W3CDTF">2021-07-12T11:29:48Z</dcterms:modified>
</cp:coreProperties>
</file>